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1.xml" ContentType="application/vnd.openxmlformats-officedocument.presentationml.notesSl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6"/>
  </p:notesMasterIdLst>
  <p:sldIdLst>
    <p:sldId id="285" r:id="rId2"/>
    <p:sldId id="272" r:id="rId3"/>
    <p:sldId id="270" r:id="rId4"/>
    <p:sldId id="273" r:id="rId5"/>
  </p:sldIdLst>
  <p:sldSz cx="19442113" cy="10080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15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26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E80+TS_2\E80_J3\&#12487;&#12540;&#12479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E80+TS_2\E80_J3\&#12487;&#12540;&#12479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E80+TS_2\E80_J3\150516_E80&#38500;&#31070;&#32076;&#12510;&#12454;&#12473;_Gastro_RTPCR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E80+TS_2\E80_J3\150516_E80&#38500;&#31070;&#32076;&#12510;&#12454;&#12473;_Gastro_RTPCR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4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 dirty="0"/>
              <a:t>Gastro Wet </a:t>
            </a:r>
            <a:r>
              <a:rPr lang="en-US" altLang="ja-JP" sz="4800" b="0" i="0" u="none" strike="noStrike" baseline="0" dirty="0">
                <a:effectLst/>
              </a:rPr>
              <a:t>Mass</a:t>
            </a:r>
            <a:endParaRPr lang="ja-JP" dirty="0"/>
          </a:p>
        </c:rich>
      </c:tx>
      <c:layout>
        <c:manualLayout>
          <c:xMode val="edge"/>
          <c:yMode val="edge"/>
          <c:x val="0.29853700782228304"/>
          <c:y val="1.889763966992519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4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4060506739396195"/>
          <c:y val="9.8277249503602157E-2"/>
          <c:w val="0.78323785887978903"/>
          <c:h val="0.7388798550565917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EF3-4B40-B4C7-AC3C8D2E1201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EF3-4B40-B4C7-AC3C8D2E1201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EF3-4B40-B4C7-AC3C8D2E1201}"/>
              </c:ext>
            </c:extLst>
          </c:dPt>
          <c:errBars>
            <c:errBarType val="plus"/>
            <c:errValType val="cust"/>
            <c:noEndCap val="0"/>
            <c:plus>
              <c:numRef>
                <c:f>筋湿重量!$W$35:$AB$35</c:f>
                <c:numCache>
                  <c:formatCode>General</c:formatCode>
                  <c:ptCount val="6"/>
                  <c:pt idx="0">
                    <c:v>2.5720665829054772</c:v>
                  </c:pt>
                  <c:pt idx="1">
                    <c:v>2.4126230162306541</c:v>
                  </c:pt>
                  <c:pt idx="2">
                    <c:v>4.6579293010951615</c:v>
                  </c:pt>
                  <c:pt idx="3">
                    <c:v>2.1129975231984646</c:v>
                  </c:pt>
                  <c:pt idx="4">
                    <c:v>1.3928787137116831</c:v>
                  </c:pt>
                  <c:pt idx="5">
                    <c:v>1.71503454786284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筋湿重量!$W$32:$AB$33</c:f>
              <c:multiLvlStrCache>
                <c:ptCount val="6"/>
                <c:lvl>
                  <c:pt idx="0">
                    <c:v>Den</c:v>
                  </c:pt>
                  <c:pt idx="1">
                    <c:v>E80</c:v>
                  </c:pt>
                  <c:pt idx="2">
                    <c:v>Den</c:v>
                  </c:pt>
                  <c:pt idx="3">
                    <c:v>E80</c:v>
                  </c:pt>
                  <c:pt idx="4">
                    <c:v>Den</c:v>
                  </c:pt>
                  <c:pt idx="5">
                    <c:v>E80</c:v>
                  </c:pt>
                </c:lvl>
                <c:lvl>
                  <c:pt idx="0">
                    <c:v>0day</c:v>
                  </c:pt>
                  <c:pt idx="2">
                    <c:v>4day</c:v>
                  </c:pt>
                  <c:pt idx="4">
                    <c:v>7day</c:v>
                  </c:pt>
                </c:lvl>
              </c:multiLvlStrCache>
            </c:multiLvlStrRef>
          </c:cat>
          <c:val>
            <c:numRef>
              <c:f>筋湿重量!$W$34:$AB$34</c:f>
              <c:numCache>
                <c:formatCode>General</c:formatCode>
                <c:ptCount val="6"/>
                <c:pt idx="0">
                  <c:v>175.22222222222223</c:v>
                </c:pt>
                <c:pt idx="1">
                  <c:v>163.29444444444445</c:v>
                </c:pt>
                <c:pt idx="2">
                  <c:v>150.30555555555557</c:v>
                </c:pt>
                <c:pt idx="3">
                  <c:v>152.07222222222222</c:v>
                </c:pt>
                <c:pt idx="4">
                  <c:v>131.97500000000002</c:v>
                </c:pt>
                <c:pt idx="5">
                  <c:v>127.222222222222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EF3-4B40-B4C7-AC3C8D2E12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51197935"/>
        <c:axId val="449118863"/>
      </c:barChart>
      <c:catAx>
        <c:axId val="45119793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3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449118863"/>
        <c:crosses val="autoZero"/>
        <c:auto val="1"/>
        <c:lblAlgn val="ctr"/>
        <c:lblOffset val="100"/>
        <c:noMultiLvlLbl val="0"/>
      </c:catAx>
      <c:valAx>
        <c:axId val="4491188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45119793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4000">
          <a:latin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4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 dirty="0"/>
              <a:t>Gastro Wet </a:t>
            </a:r>
            <a:r>
              <a:rPr lang="en-US" altLang="ja-JP" sz="4800" b="0" i="0" u="none" strike="noStrike" baseline="0" dirty="0">
                <a:effectLst/>
              </a:rPr>
              <a:t>Mass</a:t>
            </a:r>
            <a:r>
              <a:rPr lang="en-US" dirty="0"/>
              <a:t> / Body Weight</a:t>
            </a:r>
            <a:endParaRPr lang="ja-JP" dirty="0"/>
          </a:p>
        </c:rich>
      </c:tx>
      <c:layout>
        <c:manualLayout>
          <c:xMode val="edge"/>
          <c:yMode val="edge"/>
          <c:x val="0.1243028996394137"/>
          <c:y val="1.119940479880959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4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2742664822339198"/>
          <c:y val="9.7766953933907857E-2"/>
          <c:w val="0.71571835195376421"/>
          <c:h val="0.7393901667803334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9CF-487F-B861-89F1353F7901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9CF-487F-B861-89F1353F7901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9CF-487F-B861-89F1353F7901}"/>
              </c:ext>
            </c:extLst>
          </c:dPt>
          <c:errBars>
            <c:errBarType val="plus"/>
            <c:errValType val="cust"/>
            <c:noEndCap val="0"/>
            <c:plus>
              <c:numRef>
                <c:f>筋湿重量!$W$21:$AB$21</c:f>
                <c:numCache>
                  <c:formatCode>General</c:formatCode>
                  <c:ptCount val="6"/>
                  <c:pt idx="0">
                    <c:v>5.9193426789640395E-2</c:v>
                  </c:pt>
                  <c:pt idx="1">
                    <c:v>8.4603484458487893E-2</c:v>
                  </c:pt>
                  <c:pt idx="2">
                    <c:v>0.12622778610098423</c:v>
                  </c:pt>
                  <c:pt idx="3">
                    <c:v>6.038019664108548E-2</c:v>
                  </c:pt>
                  <c:pt idx="4">
                    <c:v>5.7035369420812262E-2</c:v>
                  </c:pt>
                  <c:pt idx="5">
                    <c:v>3.909029660670286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筋湿重量!$W$18:$AB$19</c:f>
              <c:multiLvlStrCache>
                <c:ptCount val="6"/>
                <c:lvl>
                  <c:pt idx="0">
                    <c:v>Den</c:v>
                  </c:pt>
                  <c:pt idx="1">
                    <c:v>E80</c:v>
                  </c:pt>
                  <c:pt idx="2">
                    <c:v>Den</c:v>
                  </c:pt>
                  <c:pt idx="3">
                    <c:v>E80</c:v>
                  </c:pt>
                  <c:pt idx="4">
                    <c:v>Den</c:v>
                  </c:pt>
                  <c:pt idx="5">
                    <c:v>E80</c:v>
                  </c:pt>
                </c:lvl>
                <c:lvl>
                  <c:pt idx="0">
                    <c:v>0day</c:v>
                  </c:pt>
                  <c:pt idx="2">
                    <c:v>4day</c:v>
                  </c:pt>
                  <c:pt idx="4">
                    <c:v>7day</c:v>
                  </c:pt>
                </c:lvl>
              </c:multiLvlStrCache>
            </c:multiLvlStrRef>
          </c:cat>
          <c:val>
            <c:numRef>
              <c:f>筋湿重量!$W$20:$AB$20</c:f>
              <c:numCache>
                <c:formatCode>General</c:formatCode>
                <c:ptCount val="6"/>
                <c:pt idx="0">
                  <c:v>4.4121563066666791</c:v>
                </c:pt>
                <c:pt idx="1">
                  <c:v>4.3092127991238858</c:v>
                </c:pt>
                <c:pt idx="2">
                  <c:v>3.906031699197936</c:v>
                </c:pt>
                <c:pt idx="3">
                  <c:v>4.018613871624777</c:v>
                </c:pt>
                <c:pt idx="4">
                  <c:v>3.4236649387727498</c:v>
                </c:pt>
                <c:pt idx="5">
                  <c:v>3.3070668545367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9CF-487F-B861-89F1353F79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53985455"/>
        <c:axId val="456392783"/>
      </c:barChart>
      <c:catAx>
        <c:axId val="4539854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3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456392783"/>
        <c:crosses val="autoZero"/>
        <c:auto val="1"/>
        <c:lblAlgn val="ctr"/>
        <c:lblOffset val="100"/>
        <c:noMultiLvlLbl val="0"/>
      </c:catAx>
      <c:valAx>
        <c:axId val="45639278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4539854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4000">
          <a:latin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4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/>
              <a:t>MAFbx mRNA</a:t>
            </a:r>
            <a:endParaRPr lang="ja-JP"/>
          </a:p>
        </c:rich>
      </c:tx>
      <c:layout>
        <c:manualLayout>
          <c:xMode val="edge"/>
          <c:yMode val="edge"/>
          <c:x val="0.37487632943090005"/>
          <c:y val="1.259842519685039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4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4175448562356427"/>
          <c:y val="9.7467666935333874E-2"/>
          <c:w val="0.78969612149187773"/>
          <c:h val="0.7398621613243225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9C6-4BC0-83A3-58340F5982D4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9C6-4BC0-83A3-58340F5982D4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9C6-4BC0-83A3-58340F5982D4}"/>
              </c:ext>
            </c:extLst>
          </c:dPt>
          <c:errBars>
            <c:errBarType val="plus"/>
            <c:errValType val="cust"/>
            <c:noEndCap val="0"/>
            <c:plus>
              <c:numRef>
                <c:f>MAFbx!$AC$56:$AH$56</c:f>
                <c:numCache>
                  <c:formatCode>General</c:formatCode>
                  <c:ptCount val="6"/>
                  <c:pt idx="0">
                    <c:v>0.17691306430909035</c:v>
                  </c:pt>
                  <c:pt idx="1">
                    <c:v>0.20595981269277866</c:v>
                  </c:pt>
                  <c:pt idx="2">
                    <c:v>3.9135222710054825E-2</c:v>
                  </c:pt>
                  <c:pt idx="3">
                    <c:v>0.10535264255313737</c:v>
                  </c:pt>
                  <c:pt idx="4">
                    <c:v>0.17452750065490669</c:v>
                  </c:pt>
                  <c:pt idx="5">
                    <c:v>0.18869902817005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MAFbx!$AC$53:$AH$54</c:f>
              <c:multiLvlStrCache>
                <c:ptCount val="6"/>
                <c:lvl>
                  <c:pt idx="0">
                    <c:v>Den</c:v>
                  </c:pt>
                  <c:pt idx="1">
                    <c:v>E80</c:v>
                  </c:pt>
                  <c:pt idx="2">
                    <c:v>Den</c:v>
                  </c:pt>
                  <c:pt idx="3">
                    <c:v>E80</c:v>
                  </c:pt>
                  <c:pt idx="4">
                    <c:v>Den</c:v>
                  </c:pt>
                  <c:pt idx="5">
                    <c:v>E80</c:v>
                  </c:pt>
                </c:lvl>
                <c:lvl>
                  <c:pt idx="0">
                    <c:v>0day</c:v>
                  </c:pt>
                  <c:pt idx="2">
                    <c:v>4day</c:v>
                  </c:pt>
                  <c:pt idx="4">
                    <c:v>7day</c:v>
                  </c:pt>
                </c:lvl>
              </c:multiLvlStrCache>
            </c:multiLvlStrRef>
          </c:cat>
          <c:val>
            <c:numRef>
              <c:f>MAFbx!$AC$55:$AH$55</c:f>
              <c:numCache>
                <c:formatCode>General</c:formatCode>
                <c:ptCount val="6"/>
                <c:pt idx="0">
                  <c:v>1</c:v>
                </c:pt>
                <c:pt idx="1">
                  <c:v>0.79186880527971981</c:v>
                </c:pt>
                <c:pt idx="2">
                  <c:v>2.0420242514143871</c:v>
                </c:pt>
                <c:pt idx="3">
                  <c:v>2.7463204997497885</c:v>
                </c:pt>
                <c:pt idx="4">
                  <c:v>1.2983385881615781</c:v>
                </c:pt>
                <c:pt idx="5">
                  <c:v>1.82766290045880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9C6-4BC0-83A3-58340F5982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19142048"/>
        <c:axId val="1919255696"/>
      </c:barChart>
      <c:catAx>
        <c:axId val="1919142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3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1919255696"/>
        <c:crosses val="autoZero"/>
        <c:auto val="1"/>
        <c:lblAlgn val="ctr"/>
        <c:lblOffset val="100"/>
        <c:noMultiLvlLbl val="0"/>
      </c:catAx>
      <c:valAx>
        <c:axId val="19192556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19191420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4000">
          <a:latin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4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/>
              <a:t>Murf1 mRNA</a:t>
            </a:r>
            <a:endParaRPr lang="ja-JP"/>
          </a:p>
        </c:rich>
      </c:tx>
      <c:layout>
        <c:manualLayout>
          <c:xMode val="edge"/>
          <c:yMode val="edge"/>
          <c:x val="0.37834003001669309"/>
          <c:y val="1.217880835761671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4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4291654392321468"/>
          <c:y val="9.7467666935333874E-2"/>
          <c:w val="0.79914874612267772"/>
          <c:h val="0.7398621613243225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604-4268-909B-E21B6A494C89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604-4268-909B-E21B6A494C89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604-4268-909B-E21B6A494C89}"/>
              </c:ext>
            </c:extLst>
          </c:dPt>
          <c:errBars>
            <c:errBarType val="plus"/>
            <c:errValType val="cust"/>
            <c:noEndCap val="0"/>
            <c:plus>
              <c:numRef>
                <c:f>Murf1!$AC$56:$AH$56</c:f>
                <c:numCache>
                  <c:formatCode>General</c:formatCode>
                  <c:ptCount val="6"/>
                  <c:pt idx="0">
                    <c:v>0.14330227817202676</c:v>
                  </c:pt>
                  <c:pt idx="1">
                    <c:v>0.16285082564771194</c:v>
                  </c:pt>
                  <c:pt idx="2">
                    <c:v>0.13479759424463494</c:v>
                  </c:pt>
                  <c:pt idx="3">
                    <c:v>0.10083333333333207</c:v>
                  </c:pt>
                  <c:pt idx="4">
                    <c:v>0.24418528215312624</c:v>
                  </c:pt>
                  <c:pt idx="5">
                    <c:v>0.142457463082418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Murf1!$AC$53:$AH$54</c:f>
              <c:multiLvlStrCache>
                <c:ptCount val="6"/>
                <c:lvl>
                  <c:pt idx="0">
                    <c:v>Den</c:v>
                  </c:pt>
                  <c:pt idx="1">
                    <c:v>E80</c:v>
                  </c:pt>
                  <c:pt idx="2">
                    <c:v>Den</c:v>
                  </c:pt>
                  <c:pt idx="3">
                    <c:v>E80</c:v>
                  </c:pt>
                  <c:pt idx="4">
                    <c:v>Den</c:v>
                  </c:pt>
                  <c:pt idx="5">
                    <c:v>E80</c:v>
                  </c:pt>
                </c:lvl>
                <c:lvl>
                  <c:pt idx="0">
                    <c:v>0day</c:v>
                  </c:pt>
                  <c:pt idx="2">
                    <c:v>4day</c:v>
                  </c:pt>
                  <c:pt idx="4">
                    <c:v>7day</c:v>
                  </c:pt>
                </c:lvl>
              </c:multiLvlStrCache>
            </c:multiLvlStrRef>
          </c:cat>
          <c:val>
            <c:numRef>
              <c:f>Murf1!$AC$55:$AH$55</c:f>
              <c:numCache>
                <c:formatCode>General</c:formatCode>
                <c:ptCount val="6"/>
                <c:pt idx="0">
                  <c:v>1.0000000000000004</c:v>
                </c:pt>
                <c:pt idx="1">
                  <c:v>1.2512181394937494</c:v>
                </c:pt>
                <c:pt idx="2">
                  <c:v>4.3219029211808504</c:v>
                </c:pt>
                <c:pt idx="3">
                  <c:v>4.6967625769004409</c:v>
                </c:pt>
                <c:pt idx="4">
                  <c:v>2.5698188521096568</c:v>
                </c:pt>
                <c:pt idx="5">
                  <c:v>3.31344812597847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604-4268-909B-E21B6A494C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75606880"/>
        <c:axId val="1919268592"/>
      </c:barChart>
      <c:catAx>
        <c:axId val="19756068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3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1919268592"/>
        <c:crosses val="autoZero"/>
        <c:auto val="1"/>
        <c:lblAlgn val="ctr"/>
        <c:lblOffset val="100"/>
        <c:noMultiLvlLbl val="0"/>
      </c:catAx>
      <c:valAx>
        <c:axId val="19192685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19756068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4000">
          <a:latin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2B63C2-A032-4D9E-B0B6-B53312CCB123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54025" y="1143000"/>
            <a:ext cx="59499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5B51AC-D555-4B43-96FC-4FC8B6A641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3274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454025" y="1143000"/>
            <a:ext cx="594995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15B51AC-D555-4B43-96FC-4FC8B6A64199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87740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430264" y="1649770"/>
            <a:ext cx="14581585" cy="3509551"/>
          </a:xfrm>
        </p:spPr>
        <p:txBody>
          <a:bodyPr anchor="b"/>
          <a:lstStyle>
            <a:lvl1pPr algn="ctr">
              <a:defRPr sz="881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430264" y="5294662"/>
            <a:ext cx="14581585" cy="2433817"/>
          </a:xfrm>
        </p:spPr>
        <p:txBody>
          <a:bodyPr/>
          <a:lstStyle>
            <a:lvl1pPr marL="0" indent="0" algn="ctr">
              <a:buNone/>
              <a:defRPr sz="3528"/>
            </a:lvl1pPr>
            <a:lvl2pPr marL="672038" indent="0" algn="ctr">
              <a:buNone/>
              <a:defRPr sz="2940"/>
            </a:lvl2pPr>
            <a:lvl3pPr marL="1344077" indent="0" algn="ctr">
              <a:buNone/>
              <a:defRPr sz="2646"/>
            </a:lvl3pPr>
            <a:lvl4pPr marL="2016115" indent="0" algn="ctr">
              <a:buNone/>
              <a:defRPr sz="2352"/>
            </a:lvl4pPr>
            <a:lvl5pPr marL="2688153" indent="0" algn="ctr">
              <a:buNone/>
              <a:defRPr sz="2352"/>
            </a:lvl5pPr>
            <a:lvl6pPr marL="3360191" indent="0" algn="ctr">
              <a:buNone/>
              <a:defRPr sz="2352"/>
            </a:lvl6pPr>
            <a:lvl7pPr marL="4032230" indent="0" algn="ctr">
              <a:buNone/>
              <a:defRPr sz="2352"/>
            </a:lvl7pPr>
            <a:lvl8pPr marL="4704268" indent="0" algn="ctr">
              <a:buNone/>
              <a:defRPr sz="2352"/>
            </a:lvl8pPr>
            <a:lvl9pPr marL="5376306" indent="0" algn="ctr">
              <a:buNone/>
              <a:defRPr sz="2352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6408A-A5D3-435D-BE5D-A66865A58DD5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DAD60-E717-4324-A9B4-F3A933FB90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4813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6408A-A5D3-435D-BE5D-A66865A58DD5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DAD60-E717-4324-A9B4-F3A933FB90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21354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913262" y="536700"/>
            <a:ext cx="4192206" cy="85428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36645" y="536700"/>
            <a:ext cx="12333590" cy="85428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6408A-A5D3-435D-BE5D-A66865A58DD5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DAD60-E717-4324-A9B4-F3A933FB90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9143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6408A-A5D3-435D-BE5D-A66865A58DD5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DAD60-E717-4324-A9B4-F3A933FB90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9032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26519" y="2513157"/>
            <a:ext cx="16768822" cy="4193259"/>
          </a:xfrm>
        </p:spPr>
        <p:txBody>
          <a:bodyPr anchor="b"/>
          <a:lstStyle>
            <a:lvl1pPr>
              <a:defRPr sz="881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26519" y="6746086"/>
            <a:ext cx="16768822" cy="2205136"/>
          </a:xfrm>
        </p:spPr>
        <p:txBody>
          <a:bodyPr/>
          <a:lstStyle>
            <a:lvl1pPr marL="0" indent="0">
              <a:buNone/>
              <a:defRPr sz="3528">
                <a:solidFill>
                  <a:schemeClr val="tx1">
                    <a:tint val="75000"/>
                  </a:schemeClr>
                </a:solidFill>
              </a:defRPr>
            </a:lvl1pPr>
            <a:lvl2pPr marL="672038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2pPr>
            <a:lvl3pPr marL="1344077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3pPr>
            <a:lvl4pPr marL="2016115" indent="0">
              <a:buNone/>
              <a:defRPr sz="2352">
                <a:solidFill>
                  <a:schemeClr val="tx1">
                    <a:tint val="75000"/>
                  </a:schemeClr>
                </a:solidFill>
              </a:defRPr>
            </a:lvl4pPr>
            <a:lvl5pPr marL="2688153" indent="0">
              <a:buNone/>
              <a:defRPr sz="2352">
                <a:solidFill>
                  <a:schemeClr val="tx1">
                    <a:tint val="75000"/>
                  </a:schemeClr>
                </a:solidFill>
              </a:defRPr>
            </a:lvl5pPr>
            <a:lvl6pPr marL="3360191" indent="0">
              <a:buNone/>
              <a:defRPr sz="2352">
                <a:solidFill>
                  <a:schemeClr val="tx1">
                    <a:tint val="75000"/>
                  </a:schemeClr>
                </a:solidFill>
              </a:defRPr>
            </a:lvl6pPr>
            <a:lvl7pPr marL="4032230" indent="0">
              <a:buNone/>
              <a:defRPr sz="2352">
                <a:solidFill>
                  <a:schemeClr val="tx1">
                    <a:tint val="75000"/>
                  </a:schemeClr>
                </a:solidFill>
              </a:defRPr>
            </a:lvl7pPr>
            <a:lvl8pPr marL="4704268" indent="0">
              <a:buNone/>
              <a:defRPr sz="2352">
                <a:solidFill>
                  <a:schemeClr val="tx1">
                    <a:tint val="75000"/>
                  </a:schemeClr>
                </a:solidFill>
              </a:defRPr>
            </a:lvl8pPr>
            <a:lvl9pPr marL="5376306" indent="0">
              <a:buNone/>
              <a:defRPr sz="235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6408A-A5D3-435D-BE5D-A66865A58DD5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DAD60-E717-4324-A9B4-F3A933FB90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9270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36645" y="2683500"/>
            <a:ext cx="8262898" cy="63960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842570" y="2683500"/>
            <a:ext cx="8262898" cy="63960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6408A-A5D3-435D-BE5D-A66865A58DD5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DAD60-E717-4324-A9B4-F3A933FB90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9997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39178" y="536701"/>
            <a:ext cx="16768822" cy="194845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39179" y="2471154"/>
            <a:ext cx="8224924" cy="1211074"/>
          </a:xfrm>
        </p:spPr>
        <p:txBody>
          <a:bodyPr anchor="b"/>
          <a:lstStyle>
            <a:lvl1pPr marL="0" indent="0">
              <a:buNone/>
              <a:defRPr sz="3528" b="1"/>
            </a:lvl1pPr>
            <a:lvl2pPr marL="672038" indent="0">
              <a:buNone/>
              <a:defRPr sz="2940" b="1"/>
            </a:lvl2pPr>
            <a:lvl3pPr marL="1344077" indent="0">
              <a:buNone/>
              <a:defRPr sz="2646" b="1"/>
            </a:lvl3pPr>
            <a:lvl4pPr marL="2016115" indent="0">
              <a:buNone/>
              <a:defRPr sz="2352" b="1"/>
            </a:lvl4pPr>
            <a:lvl5pPr marL="2688153" indent="0">
              <a:buNone/>
              <a:defRPr sz="2352" b="1"/>
            </a:lvl5pPr>
            <a:lvl6pPr marL="3360191" indent="0">
              <a:buNone/>
              <a:defRPr sz="2352" b="1"/>
            </a:lvl6pPr>
            <a:lvl7pPr marL="4032230" indent="0">
              <a:buNone/>
              <a:defRPr sz="2352" b="1"/>
            </a:lvl7pPr>
            <a:lvl8pPr marL="4704268" indent="0">
              <a:buNone/>
              <a:defRPr sz="2352" b="1"/>
            </a:lvl8pPr>
            <a:lvl9pPr marL="5376306" indent="0">
              <a:buNone/>
              <a:defRPr sz="2352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39179" y="3682228"/>
            <a:ext cx="8224924" cy="54160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842570" y="2471154"/>
            <a:ext cx="8265430" cy="1211074"/>
          </a:xfrm>
        </p:spPr>
        <p:txBody>
          <a:bodyPr anchor="b"/>
          <a:lstStyle>
            <a:lvl1pPr marL="0" indent="0">
              <a:buNone/>
              <a:defRPr sz="3528" b="1"/>
            </a:lvl1pPr>
            <a:lvl2pPr marL="672038" indent="0">
              <a:buNone/>
              <a:defRPr sz="2940" b="1"/>
            </a:lvl2pPr>
            <a:lvl3pPr marL="1344077" indent="0">
              <a:buNone/>
              <a:defRPr sz="2646" b="1"/>
            </a:lvl3pPr>
            <a:lvl4pPr marL="2016115" indent="0">
              <a:buNone/>
              <a:defRPr sz="2352" b="1"/>
            </a:lvl4pPr>
            <a:lvl5pPr marL="2688153" indent="0">
              <a:buNone/>
              <a:defRPr sz="2352" b="1"/>
            </a:lvl5pPr>
            <a:lvl6pPr marL="3360191" indent="0">
              <a:buNone/>
              <a:defRPr sz="2352" b="1"/>
            </a:lvl6pPr>
            <a:lvl7pPr marL="4032230" indent="0">
              <a:buNone/>
              <a:defRPr sz="2352" b="1"/>
            </a:lvl7pPr>
            <a:lvl8pPr marL="4704268" indent="0">
              <a:buNone/>
              <a:defRPr sz="2352" b="1"/>
            </a:lvl8pPr>
            <a:lvl9pPr marL="5376306" indent="0">
              <a:buNone/>
              <a:defRPr sz="2352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842570" y="3682228"/>
            <a:ext cx="8265430" cy="54160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6408A-A5D3-435D-BE5D-A66865A58DD5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DAD60-E717-4324-A9B4-F3A933FB90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0996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6408A-A5D3-435D-BE5D-A66865A58DD5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DAD60-E717-4324-A9B4-F3A933FB90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0506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6408A-A5D3-435D-BE5D-A66865A58DD5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DAD60-E717-4324-A9B4-F3A933FB90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255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39178" y="672042"/>
            <a:ext cx="6270587" cy="2352146"/>
          </a:xfrm>
        </p:spPr>
        <p:txBody>
          <a:bodyPr anchor="b"/>
          <a:lstStyle>
            <a:lvl1pPr>
              <a:defRPr sz="470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265430" y="1451424"/>
            <a:ext cx="9842570" cy="7163777"/>
          </a:xfrm>
        </p:spPr>
        <p:txBody>
          <a:bodyPr/>
          <a:lstStyle>
            <a:lvl1pPr>
              <a:defRPr sz="4704"/>
            </a:lvl1pPr>
            <a:lvl2pPr>
              <a:defRPr sz="4116"/>
            </a:lvl2pPr>
            <a:lvl3pPr>
              <a:defRPr sz="3528"/>
            </a:lvl3pPr>
            <a:lvl4pPr>
              <a:defRPr sz="2940"/>
            </a:lvl4pPr>
            <a:lvl5pPr>
              <a:defRPr sz="2940"/>
            </a:lvl5pPr>
            <a:lvl6pPr>
              <a:defRPr sz="2940"/>
            </a:lvl6pPr>
            <a:lvl7pPr>
              <a:defRPr sz="2940"/>
            </a:lvl7pPr>
            <a:lvl8pPr>
              <a:defRPr sz="2940"/>
            </a:lvl8pPr>
            <a:lvl9pPr>
              <a:defRPr sz="294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39178" y="3024188"/>
            <a:ext cx="6270587" cy="5602681"/>
          </a:xfrm>
        </p:spPr>
        <p:txBody>
          <a:bodyPr/>
          <a:lstStyle>
            <a:lvl1pPr marL="0" indent="0">
              <a:buNone/>
              <a:defRPr sz="2352"/>
            </a:lvl1pPr>
            <a:lvl2pPr marL="672038" indent="0">
              <a:buNone/>
              <a:defRPr sz="2058"/>
            </a:lvl2pPr>
            <a:lvl3pPr marL="1344077" indent="0">
              <a:buNone/>
              <a:defRPr sz="1764"/>
            </a:lvl3pPr>
            <a:lvl4pPr marL="2016115" indent="0">
              <a:buNone/>
              <a:defRPr sz="1470"/>
            </a:lvl4pPr>
            <a:lvl5pPr marL="2688153" indent="0">
              <a:buNone/>
              <a:defRPr sz="1470"/>
            </a:lvl5pPr>
            <a:lvl6pPr marL="3360191" indent="0">
              <a:buNone/>
              <a:defRPr sz="1470"/>
            </a:lvl6pPr>
            <a:lvl7pPr marL="4032230" indent="0">
              <a:buNone/>
              <a:defRPr sz="1470"/>
            </a:lvl7pPr>
            <a:lvl8pPr marL="4704268" indent="0">
              <a:buNone/>
              <a:defRPr sz="1470"/>
            </a:lvl8pPr>
            <a:lvl9pPr marL="5376306" indent="0">
              <a:buNone/>
              <a:defRPr sz="147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6408A-A5D3-435D-BE5D-A66865A58DD5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DAD60-E717-4324-A9B4-F3A933FB90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0603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39178" y="672042"/>
            <a:ext cx="6270587" cy="2352146"/>
          </a:xfrm>
        </p:spPr>
        <p:txBody>
          <a:bodyPr anchor="b"/>
          <a:lstStyle>
            <a:lvl1pPr>
              <a:defRPr sz="470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265430" y="1451424"/>
            <a:ext cx="9842570" cy="7163777"/>
          </a:xfrm>
        </p:spPr>
        <p:txBody>
          <a:bodyPr anchor="t"/>
          <a:lstStyle>
            <a:lvl1pPr marL="0" indent="0">
              <a:buNone/>
              <a:defRPr sz="4704"/>
            </a:lvl1pPr>
            <a:lvl2pPr marL="672038" indent="0">
              <a:buNone/>
              <a:defRPr sz="4116"/>
            </a:lvl2pPr>
            <a:lvl3pPr marL="1344077" indent="0">
              <a:buNone/>
              <a:defRPr sz="3528"/>
            </a:lvl3pPr>
            <a:lvl4pPr marL="2016115" indent="0">
              <a:buNone/>
              <a:defRPr sz="2940"/>
            </a:lvl4pPr>
            <a:lvl5pPr marL="2688153" indent="0">
              <a:buNone/>
              <a:defRPr sz="2940"/>
            </a:lvl5pPr>
            <a:lvl6pPr marL="3360191" indent="0">
              <a:buNone/>
              <a:defRPr sz="2940"/>
            </a:lvl6pPr>
            <a:lvl7pPr marL="4032230" indent="0">
              <a:buNone/>
              <a:defRPr sz="2940"/>
            </a:lvl7pPr>
            <a:lvl8pPr marL="4704268" indent="0">
              <a:buNone/>
              <a:defRPr sz="2940"/>
            </a:lvl8pPr>
            <a:lvl9pPr marL="5376306" indent="0">
              <a:buNone/>
              <a:defRPr sz="294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39178" y="3024188"/>
            <a:ext cx="6270587" cy="5602681"/>
          </a:xfrm>
        </p:spPr>
        <p:txBody>
          <a:bodyPr/>
          <a:lstStyle>
            <a:lvl1pPr marL="0" indent="0">
              <a:buNone/>
              <a:defRPr sz="2352"/>
            </a:lvl1pPr>
            <a:lvl2pPr marL="672038" indent="0">
              <a:buNone/>
              <a:defRPr sz="2058"/>
            </a:lvl2pPr>
            <a:lvl3pPr marL="1344077" indent="0">
              <a:buNone/>
              <a:defRPr sz="1764"/>
            </a:lvl3pPr>
            <a:lvl4pPr marL="2016115" indent="0">
              <a:buNone/>
              <a:defRPr sz="1470"/>
            </a:lvl4pPr>
            <a:lvl5pPr marL="2688153" indent="0">
              <a:buNone/>
              <a:defRPr sz="1470"/>
            </a:lvl5pPr>
            <a:lvl6pPr marL="3360191" indent="0">
              <a:buNone/>
              <a:defRPr sz="1470"/>
            </a:lvl6pPr>
            <a:lvl7pPr marL="4032230" indent="0">
              <a:buNone/>
              <a:defRPr sz="1470"/>
            </a:lvl7pPr>
            <a:lvl8pPr marL="4704268" indent="0">
              <a:buNone/>
              <a:defRPr sz="1470"/>
            </a:lvl8pPr>
            <a:lvl9pPr marL="5376306" indent="0">
              <a:buNone/>
              <a:defRPr sz="147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6408A-A5D3-435D-BE5D-A66865A58DD5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DAD60-E717-4324-A9B4-F3A933FB90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271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36646" y="536701"/>
            <a:ext cx="16768822" cy="1948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36646" y="2683500"/>
            <a:ext cx="16768822" cy="63960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36645" y="9343247"/>
            <a:ext cx="4374475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96408A-A5D3-435D-BE5D-A66865A58DD5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440200" y="9343247"/>
            <a:ext cx="6561713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730993" y="9343247"/>
            <a:ext cx="4374475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DDAD60-E717-4324-A9B4-F3A933FB90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35332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344077" rtl="0" eaLnBrk="1" latinLnBrk="0" hangingPunct="1">
        <a:lnSpc>
          <a:spcPct val="90000"/>
        </a:lnSpc>
        <a:spcBef>
          <a:spcPct val="0"/>
        </a:spcBef>
        <a:buNone/>
        <a:defRPr kumimoji="1" sz="646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6019" indent="-336019" algn="l" defTabSz="1344077" rtl="0" eaLnBrk="1" latinLnBrk="0" hangingPunct="1">
        <a:lnSpc>
          <a:spcPct val="90000"/>
        </a:lnSpc>
        <a:spcBef>
          <a:spcPts val="1470"/>
        </a:spcBef>
        <a:buFont typeface="Arial" panose="020B0604020202020204" pitchFamily="34" charset="0"/>
        <a:buChar char="•"/>
        <a:defRPr kumimoji="1" sz="4116" kern="1200">
          <a:solidFill>
            <a:schemeClr val="tx1"/>
          </a:solidFill>
          <a:latin typeface="+mn-lt"/>
          <a:ea typeface="+mn-ea"/>
          <a:cs typeface="+mn-cs"/>
        </a:defRPr>
      </a:lvl1pPr>
      <a:lvl2pPr marL="1008057" indent="-336019" algn="l" defTabSz="1344077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kumimoji="1" sz="3528" kern="1200">
          <a:solidFill>
            <a:schemeClr val="tx1"/>
          </a:solidFill>
          <a:latin typeface="+mn-lt"/>
          <a:ea typeface="+mn-ea"/>
          <a:cs typeface="+mn-cs"/>
        </a:defRPr>
      </a:lvl2pPr>
      <a:lvl3pPr marL="1680096" indent="-336019" algn="l" defTabSz="1344077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3pPr>
      <a:lvl4pPr marL="2352134" indent="-336019" algn="l" defTabSz="1344077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4pPr>
      <a:lvl5pPr marL="3024172" indent="-336019" algn="l" defTabSz="1344077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5pPr>
      <a:lvl6pPr marL="3696211" indent="-336019" algn="l" defTabSz="1344077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6pPr>
      <a:lvl7pPr marL="4368249" indent="-336019" algn="l" defTabSz="1344077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7pPr>
      <a:lvl8pPr marL="5040287" indent="-336019" algn="l" defTabSz="1344077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8pPr>
      <a:lvl9pPr marL="5712325" indent="-336019" algn="l" defTabSz="1344077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44077" rtl="0" eaLnBrk="1" latinLnBrk="0" hangingPunct="1"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1pPr>
      <a:lvl2pPr marL="672038" algn="l" defTabSz="1344077" rtl="0" eaLnBrk="1" latinLnBrk="0" hangingPunct="1"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344077" algn="l" defTabSz="1344077" rtl="0" eaLnBrk="1" latinLnBrk="0" hangingPunct="1"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3pPr>
      <a:lvl4pPr marL="2016115" algn="l" defTabSz="1344077" rtl="0" eaLnBrk="1" latinLnBrk="0" hangingPunct="1"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4pPr>
      <a:lvl5pPr marL="2688153" algn="l" defTabSz="1344077" rtl="0" eaLnBrk="1" latinLnBrk="0" hangingPunct="1"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5pPr>
      <a:lvl6pPr marL="3360191" algn="l" defTabSz="1344077" rtl="0" eaLnBrk="1" latinLnBrk="0" hangingPunct="1"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6pPr>
      <a:lvl7pPr marL="4032230" algn="l" defTabSz="1344077" rtl="0" eaLnBrk="1" latinLnBrk="0" hangingPunct="1"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7pPr>
      <a:lvl8pPr marL="4704268" algn="l" defTabSz="1344077" rtl="0" eaLnBrk="1" latinLnBrk="0" hangingPunct="1"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8pPr>
      <a:lvl9pPr marL="5376306" algn="l" defTabSz="1344077" rtl="0" eaLnBrk="1" latinLnBrk="0" hangingPunct="1"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36587173-EF8A-429E-B833-3A391423859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704972532"/>
              </p:ext>
            </p:extLst>
          </p:nvPr>
        </p:nvGraphicFramePr>
        <p:xfrm>
          <a:off x="3699410" y="1"/>
          <a:ext cx="10228216" cy="100806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4EB1D14-E3AF-45B8-9590-BEA513A20C78}"/>
              </a:ext>
            </a:extLst>
          </p:cNvPr>
          <p:cNvSpPr txBox="1"/>
          <p:nvPr/>
        </p:nvSpPr>
        <p:spPr>
          <a:xfrm>
            <a:off x="3899828" y="300383"/>
            <a:ext cx="1097280" cy="4770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2500" dirty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(mg)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026EA50-F8C2-4148-9D9F-23036BFEF136}"/>
              </a:ext>
            </a:extLst>
          </p:cNvPr>
          <p:cNvSpPr txBox="1"/>
          <p:nvPr/>
        </p:nvSpPr>
        <p:spPr>
          <a:xfrm>
            <a:off x="1" y="25758"/>
            <a:ext cx="3721994" cy="16312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 a</a:t>
            </a:r>
          </a:p>
        </p:txBody>
      </p:sp>
    </p:spTree>
    <p:extLst>
      <p:ext uri="{BB962C8B-B14F-4D97-AF65-F5344CB8AC3E}">
        <p14:creationId xmlns:p14="http://schemas.microsoft.com/office/powerpoint/2010/main" val="33148039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" name="グラフ 23">
            <a:extLst>
              <a:ext uri="{FF2B5EF4-FFF2-40B4-BE49-F238E27FC236}">
                <a16:creationId xmlns:a16="http://schemas.microsoft.com/office/drawing/2014/main" id="{C5FA080D-9B25-43DB-9FBF-D65573BD95F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086673823"/>
              </p:ext>
            </p:extLst>
          </p:nvPr>
        </p:nvGraphicFramePr>
        <p:xfrm>
          <a:off x="3788507" y="0"/>
          <a:ext cx="11204807" cy="100806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90EC46A-F455-4138-AE7B-ABDC5820E13B}"/>
              </a:ext>
            </a:extLst>
          </p:cNvPr>
          <p:cNvSpPr txBox="1"/>
          <p:nvPr/>
        </p:nvSpPr>
        <p:spPr>
          <a:xfrm>
            <a:off x="1" y="25758"/>
            <a:ext cx="3721994" cy="16312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 b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69F76914-56FF-4D46-BFCD-1E73F718D8AF}"/>
              </a:ext>
            </a:extLst>
          </p:cNvPr>
          <p:cNvSpPr txBox="1"/>
          <p:nvPr/>
        </p:nvSpPr>
        <p:spPr>
          <a:xfrm>
            <a:off x="3964856" y="254609"/>
            <a:ext cx="1097280" cy="4770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2500" dirty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(A.U.)</a:t>
            </a:r>
          </a:p>
        </p:txBody>
      </p:sp>
    </p:spTree>
    <p:extLst>
      <p:ext uri="{BB962C8B-B14F-4D97-AF65-F5344CB8AC3E}">
        <p14:creationId xmlns:p14="http://schemas.microsoft.com/office/powerpoint/2010/main" val="2780818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6E3DF33-0F92-459A-81AC-D2D38859CB4F}"/>
              </a:ext>
            </a:extLst>
          </p:cNvPr>
          <p:cNvSpPr txBox="1"/>
          <p:nvPr/>
        </p:nvSpPr>
        <p:spPr>
          <a:xfrm>
            <a:off x="1" y="25758"/>
            <a:ext cx="3721994" cy="16312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 c</a:t>
            </a:r>
          </a:p>
        </p:txBody>
      </p:sp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E288DD82-CA55-4263-803A-7672AEB948F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454578946"/>
              </p:ext>
            </p:extLst>
          </p:nvPr>
        </p:nvGraphicFramePr>
        <p:xfrm>
          <a:off x="3979572" y="-1"/>
          <a:ext cx="10146917" cy="100806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5">
            <a:extLst>
              <a:ext uri="{FF2B5EF4-FFF2-40B4-BE49-F238E27FC236}">
                <a16:creationId xmlns:a16="http://schemas.microsoft.com/office/drawing/2014/main" id="{A01C542B-705C-4722-9FD1-63417E1FE3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6046" y="-805155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4EB1D14-E3AF-45B8-9590-BEA513A20C78}"/>
              </a:ext>
            </a:extLst>
          </p:cNvPr>
          <p:cNvSpPr txBox="1"/>
          <p:nvPr/>
        </p:nvSpPr>
        <p:spPr>
          <a:xfrm>
            <a:off x="4121357" y="291309"/>
            <a:ext cx="1097280" cy="4770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2500" dirty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(A.U.)</a:t>
            </a:r>
          </a:p>
        </p:txBody>
      </p:sp>
    </p:spTree>
    <p:extLst>
      <p:ext uri="{BB962C8B-B14F-4D97-AF65-F5344CB8AC3E}">
        <p14:creationId xmlns:p14="http://schemas.microsoft.com/office/powerpoint/2010/main" val="10778861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D485479-589F-4212-949D-68EF958A18A8}"/>
              </a:ext>
            </a:extLst>
          </p:cNvPr>
          <p:cNvSpPr txBox="1"/>
          <p:nvPr/>
        </p:nvSpPr>
        <p:spPr>
          <a:xfrm>
            <a:off x="1" y="25758"/>
            <a:ext cx="3721994" cy="16312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 d</a:t>
            </a:r>
          </a:p>
        </p:txBody>
      </p:sp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78D8D62D-92C2-4EA1-BFDA-B5800FFBC27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095718364"/>
              </p:ext>
            </p:extLst>
          </p:nvPr>
        </p:nvGraphicFramePr>
        <p:xfrm>
          <a:off x="3956991" y="0"/>
          <a:ext cx="10031085" cy="100806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C7F6685-8DBF-4AF3-A2DF-32D2DE6874EA}"/>
              </a:ext>
            </a:extLst>
          </p:cNvPr>
          <p:cNvSpPr txBox="1"/>
          <p:nvPr/>
        </p:nvSpPr>
        <p:spPr>
          <a:xfrm>
            <a:off x="4133338" y="268260"/>
            <a:ext cx="1097280" cy="4770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2500" dirty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(A.U.)</a:t>
            </a:r>
          </a:p>
        </p:txBody>
      </p:sp>
    </p:spTree>
    <p:extLst>
      <p:ext uri="{BB962C8B-B14F-4D97-AF65-F5344CB8AC3E}">
        <p14:creationId xmlns:p14="http://schemas.microsoft.com/office/powerpoint/2010/main" val="1238314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272</TotalTime>
  <Words>48</Words>
  <Application>Microsoft Office PowerPoint</Application>
  <PresentationFormat>ユーザー設定</PresentationFormat>
  <Paragraphs>13</Paragraphs>
  <Slides>4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青木祐樹</dc:creator>
  <cp:lastModifiedBy>青木祐樹</cp:lastModifiedBy>
  <cp:revision>81</cp:revision>
  <dcterms:created xsi:type="dcterms:W3CDTF">2019-05-10T00:21:10Z</dcterms:created>
  <dcterms:modified xsi:type="dcterms:W3CDTF">2019-07-07T23:08:29Z</dcterms:modified>
</cp:coreProperties>
</file>